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60" r:id="rId1"/>
  </p:sldMasterIdLst>
  <p:notesMasterIdLst>
    <p:notesMasterId r:id="rId6"/>
  </p:notesMasterIdLst>
  <p:sldIdLst>
    <p:sldId id="283" r:id="rId2"/>
    <p:sldId id="287" r:id="rId3"/>
    <p:sldId id="285" r:id="rId4"/>
    <p:sldId id="28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eonie Fransen" initials="LF" lastIdx="4" clrIdx="0">
    <p:extLst>
      <p:ext uri="{19B8F6BF-5375-455C-9EA6-DF929625EA0E}">
        <p15:presenceInfo xmlns:p15="http://schemas.microsoft.com/office/powerpoint/2012/main" userId="S::Leonie.Fransen@phe.gov.uk::bee1d87f-5e12-4bd2-81ab-d157997ac70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CABAB"/>
    <a:srgbClr val="FF00FF"/>
    <a:srgbClr val="9900CC"/>
    <a:srgbClr val="FF4848"/>
    <a:srgbClr val="00D600"/>
    <a:srgbClr val="FF9933"/>
    <a:srgbClr val="0099FF"/>
    <a:srgbClr val="FA9600"/>
    <a:srgbClr val="E7D2AD"/>
    <a:srgbClr val="FF47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769" autoAdjust="0"/>
    <p:restoredTop sz="82956" autoAdjust="0"/>
  </p:normalViewPr>
  <p:slideViewPr>
    <p:cSldViewPr snapToGrid="0">
      <p:cViewPr varScale="1">
        <p:scale>
          <a:sx n="62" d="100"/>
          <a:sy n="62" d="100"/>
        </p:scale>
        <p:origin x="2184" y="84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image" Target="../media/image6.emf"/><Relationship Id="rId4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8D65C2-0F4F-4545-B3A2-F28373542DE2}" type="datetimeFigureOut">
              <a:rPr lang="en-GB" smtClean="0"/>
              <a:t>15/03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1D2DA5-2C7A-426C-9893-181D72DE36D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38461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1D2DA5-2C7A-426C-9893-181D72DE36DA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14231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1D2DA5-2C7A-426C-9893-181D72DE36DA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425577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1D2DA5-2C7A-426C-9893-181D72DE36DA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054934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1D2DA5-2C7A-426C-9893-181D72DE36DA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76818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68BA5-BB81-4175-9E7A-86D6F37D8E48}" type="datetimeFigureOut">
              <a:rPr lang="en-GB" smtClean="0"/>
              <a:t>15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2C6D8-B717-4499-B8AA-8501C6B407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5471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68BA5-BB81-4175-9E7A-86D6F37D8E48}" type="datetimeFigureOut">
              <a:rPr lang="en-GB" smtClean="0"/>
              <a:t>15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2C6D8-B717-4499-B8AA-8501C6B407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4394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68BA5-BB81-4175-9E7A-86D6F37D8E48}" type="datetimeFigureOut">
              <a:rPr lang="en-GB" smtClean="0"/>
              <a:t>15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2C6D8-B717-4499-B8AA-8501C6B407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1834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68BA5-BB81-4175-9E7A-86D6F37D8E48}" type="datetimeFigureOut">
              <a:rPr lang="en-GB" smtClean="0"/>
              <a:t>15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2C6D8-B717-4499-B8AA-8501C6B407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0131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68BA5-BB81-4175-9E7A-86D6F37D8E48}" type="datetimeFigureOut">
              <a:rPr lang="en-GB" smtClean="0"/>
              <a:t>15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2C6D8-B717-4499-B8AA-8501C6B407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15711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68BA5-BB81-4175-9E7A-86D6F37D8E48}" type="datetimeFigureOut">
              <a:rPr lang="en-GB" smtClean="0"/>
              <a:t>15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2C6D8-B717-4499-B8AA-8501C6B407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6260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68BA5-BB81-4175-9E7A-86D6F37D8E48}" type="datetimeFigureOut">
              <a:rPr lang="en-GB" smtClean="0"/>
              <a:t>15/03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2C6D8-B717-4499-B8AA-8501C6B407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4287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68BA5-BB81-4175-9E7A-86D6F37D8E48}" type="datetimeFigureOut">
              <a:rPr lang="en-GB" smtClean="0"/>
              <a:t>15/03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2C6D8-B717-4499-B8AA-8501C6B407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65974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68BA5-BB81-4175-9E7A-86D6F37D8E48}" type="datetimeFigureOut">
              <a:rPr lang="en-GB" smtClean="0"/>
              <a:t>15/03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2C6D8-B717-4499-B8AA-8501C6B407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633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68BA5-BB81-4175-9E7A-86D6F37D8E48}" type="datetimeFigureOut">
              <a:rPr lang="en-GB" smtClean="0"/>
              <a:t>15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2C6D8-B717-4499-B8AA-8501C6B407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1062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68BA5-BB81-4175-9E7A-86D6F37D8E48}" type="datetimeFigureOut">
              <a:rPr lang="en-GB" smtClean="0"/>
              <a:t>15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2C6D8-B717-4499-B8AA-8501C6B407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8102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68BA5-BB81-4175-9E7A-86D6F37D8E48}" type="datetimeFigureOut">
              <a:rPr lang="en-GB" smtClean="0"/>
              <a:t>15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B2C6D8-B717-4499-B8AA-8501C6B407B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8136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7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9.emf"/><Relationship Id="rId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DF5263F-57CB-4F0B-9D37-E2ED2049A46F}"/>
              </a:ext>
            </a:extLst>
          </p:cNvPr>
          <p:cNvSpPr txBox="1"/>
          <p:nvPr/>
        </p:nvSpPr>
        <p:spPr>
          <a:xfrm>
            <a:off x="4761220" y="192680"/>
            <a:ext cx="19399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B06B21F0-798A-4304-878F-828724D873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29523" y="2838924"/>
            <a:ext cx="1016426" cy="177199"/>
          </a:xfrm>
          <a:prstGeom prst="rect">
            <a:avLst/>
          </a:prstGeom>
        </p:spPr>
      </p:pic>
      <p:grpSp>
        <p:nvGrpSpPr>
          <p:cNvPr id="26" name="Group 25">
            <a:extLst>
              <a:ext uri="{FF2B5EF4-FFF2-40B4-BE49-F238E27FC236}">
                <a16:creationId xmlns:a16="http://schemas.microsoft.com/office/drawing/2014/main" id="{B1350CAC-82FA-40F4-8911-7DE573373531}"/>
              </a:ext>
            </a:extLst>
          </p:cNvPr>
          <p:cNvGrpSpPr/>
          <p:nvPr/>
        </p:nvGrpSpPr>
        <p:grpSpPr>
          <a:xfrm>
            <a:off x="2702727" y="2029674"/>
            <a:ext cx="1749013" cy="754710"/>
            <a:chOff x="3769434" y="1831657"/>
            <a:chExt cx="1749013" cy="754710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F8222C3C-FC51-4E56-B257-A44DB3DD166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779043" y="2020836"/>
              <a:ext cx="1364265" cy="327173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828DED9-733C-445A-A4BA-0EBD3CC72E16}"/>
                </a:ext>
              </a:extLst>
            </p:cNvPr>
            <p:cNvSpPr txBox="1"/>
            <p:nvPr/>
          </p:nvSpPr>
          <p:spPr>
            <a:xfrm>
              <a:off x="3829522" y="1831657"/>
              <a:ext cx="134043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DM &amp; Phagocytotic Receptors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A120DF0-385B-476C-A7E6-5DB6A1DBA7DF}"/>
                </a:ext>
              </a:extLst>
            </p:cNvPr>
            <p:cNvSpPr txBox="1"/>
            <p:nvPr/>
          </p:nvSpPr>
          <p:spPr>
            <a:xfrm>
              <a:off x="5059839" y="1989748"/>
              <a:ext cx="458608" cy="41293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D14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D36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LEC7A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OLR1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TLR4</a:t>
              </a:r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942B18B4-18DE-4104-87C7-BF9289BD3E4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769434" y="2353753"/>
              <a:ext cx="1392165" cy="232614"/>
            </a:xfrm>
            <a:prstGeom prst="rect">
              <a:avLst/>
            </a:prstGeom>
          </p:spPr>
        </p:pic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F7004769-FEC9-4454-9B12-4A041FF0BD84}"/>
              </a:ext>
            </a:extLst>
          </p:cNvPr>
          <p:cNvGrpSpPr/>
          <p:nvPr/>
        </p:nvGrpSpPr>
        <p:grpSpPr>
          <a:xfrm>
            <a:off x="2685007" y="3431445"/>
            <a:ext cx="2076213" cy="1965668"/>
            <a:chOff x="957500" y="2458031"/>
            <a:chExt cx="2076213" cy="196566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CE7DCC63-26D8-4CE5-BC0F-6DACB7193E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r="52522" b="995"/>
            <a:stretch/>
          </p:blipFill>
          <p:spPr>
            <a:xfrm>
              <a:off x="1749865" y="2543078"/>
              <a:ext cx="632893" cy="1614586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532E783-5C49-4B30-B6C5-CB03DB38E19F}"/>
                </a:ext>
              </a:extLst>
            </p:cNvPr>
            <p:cNvSpPr txBox="1"/>
            <p:nvPr/>
          </p:nvSpPr>
          <p:spPr>
            <a:xfrm>
              <a:off x="1849727" y="2463037"/>
              <a:ext cx="4586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/>
                <a:t>CD34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70CC0625-0838-44F3-B21F-71B736B840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-487" r="48924" b="487"/>
            <a:stretch/>
          </p:blipFill>
          <p:spPr>
            <a:xfrm>
              <a:off x="957500" y="2543078"/>
              <a:ext cx="780014" cy="1614586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021E8AE-6CED-4A7D-A6B4-A9DCCC76A5E8}"/>
                </a:ext>
              </a:extLst>
            </p:cNvPr>
            <p:cNvSpPr txBox="1"/>
            <p:nvPr/>
          </p:nvSpPr>
          <p:spPr>
            <a:xfrm>
              <a:off x="1222130" y="2458031"/>
              <a:ext cx="3449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b="1" dirty="0"/>
                <a:t>iPSC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19F3A24-6202-4237-9544-AA91960CFC6E}"/>
                </a:ext>
              </a:extLst>
            </p:cNvPr>
            <p:cNvSpPr txBox="1"/>
            <p:nvPr/>
          </p:nvSpPr>
          <p:spPr>
            <a:xfrm>
              <a:off x="2280503" y="2528788"/>
              <a:ext cx="753210" cy="175945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>
                <a:lnSpc>
                  <a:spcPts val="500"/>
                </a:lnSpc>
              </a:pPr>
              <a:r>
                <a:rPr lang="en-GB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Endothelial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ENG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PECAM1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VCAM1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VWF</a:t>
              </a:r>
            </a:p>
            <a:p>
              <a:pPr>
                <a:lnSpc>
                  <a:spcPts val="500"/>
                </a:lnSpc>
              </a:pPr>
              <a:r>
                <a:rPr lang="en-GB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Epithelial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DH1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DSP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MUC1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TJP1</a:t>
              </a:r>
            </a:p>
            <a:p>
              <a:pPr>
                <a:lnSpc>
                  <a:spcPts val="500"/>
                </a:lnSpc>
              </a:pPr>
              <a:r>
                <a:rPr lang="en-GB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Mesenchymal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ACTA2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CDC80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OL1A1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OL3A1</a:t>
              </a:r>
            </a:p>
            <a:p>
              <a:pPr>
                <a:lnSpc>
                  <a:spcPts val="500"/>
                </a:lnSpc>
              </a:pPr>
              <a:r>
                <a:rPr lang="en-GB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Hepatocyte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ABCC2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AFP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CPS1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SERPINA1</a:t>
              </a:r>
            </a:p>
            <a:p>
              <a:pPr>
                <a:lnSpc>
                  <a:spcPts val="500"/>
                </a:lnSpc>
              </a:pPr>
              <a:r>
                <a:rPr lang="en-GB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Neuronal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DCX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ENO2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INA</a:t>
              </a:r>
            </a:p>
            <a:p>
              <a:pPr>
                <a:lnSpc>
                  <a:spcPts val="500"/>
                </a:lnSpc>
              </a:pPr>
              <a:r>
                <a:rPr lang="en-GB" sz="500" dirty="0">
                  <a:latin typeface="Arial" panose="020B0604020202020204" pitchFamily="34" charset="0"/>
                  <a:cs typeface="Arial" panose="020B0604020202020204" pitchFamily="34" charset="0"/>
                </a:rPr>
                <a:t>MAP2</a:t>
              </a:r>
            </a:p>
            <a:p>
              <a:pPr>
                <a:lnSpc>
                  <a:spcPts val="500"/>
                </a:lnSpc>
              </a:pP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D193BF1F-BC6B-4717-ABFD-5CC481D144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r="85709"/>
            <a:stretch/>
          </p:blipFill>
          <p:spPr>
            <a:xfrm>
              <a:off x="957501" y="4157664"/>
              <a:ext cx="227545" cy="266035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007507EB-FB44-4B22-B5FF-753DE4D7EF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73068"/>
            <a:stretch/>
          </p:blipFill>
          <p:spPr>
            <a:xfrm>
              <a:off x="1962008" y="4157664"/>
              <a:ext cx="428808" cy="266035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0063A975-3D96-4B2C-96D8-F631A6F4A6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6317" r="31419"/>
            <a:stretch/>
          </p:blipFill>
          <p:spPr>
            <a:xfrm>
              <a:off x="1759271" y="4157664"/>
              <a:ext cx="195262" cy="266035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676F3C6C-2972-43A6-BC85-847C5294D3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8045" r="69676"/>
            <a:stretch/>
          </p:blipFill>
          <p:spPr>
            <a:xfrm>
              <a:off x="1185046" y="4157664"/>
              <a:ext cx="195508" cy="266035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E1B97FB4-87BC-47DF-94CC-A865192157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4945" r="43519"/>
            <a:stretch/>
          </p:blipFill>
          <p:spPr>
            <a:xfrm>
              <a:off x="1394613" y="4157664"/>
              <a:ext cx="342901" cy="266035"/>
            </a:xfrm>
            <a:prstGeom prst="rect">
              <a:avLst/>
            </a:prstGeom>
          </p:spPr>
        </p:pic>
      </p:grpSp>
      <p:sp>
        <p:nvSpPr>
          <p:cNvPr id="40" name="TextBox 39">
            <a:extLst>
              <a:ext uri="{FF2B5EF4-FFF2-40B4-BE49-F238E27FC236}">
                <a16:creationId xmlns:a16="http://schemas.microsoft.com/office/drawing/2014/main" id="{F6E5BC7C-B06D-48C8-8BF3-26F12DCE1805}"/>
              </a:ext>
            </a:extLst>
          </p:cNvPr>
          <p:cNvSpPr txBox="1"/>
          <p:nvPr/>
        </p:nvSpPr>
        <p:spPr>
          <a:xfrm>
            <a:off x="2378150" y="184315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7DA5F0B-50C8-4DCE-9FF0-45FDEF4EC03B}"/>
              </a:ext>
            </a:extLst>
          </p:cNvPr>
          <p:cNvSpPr txBox="1"/>
          <p:nvPr/>
        </p:nvSpPr>
        <p:spPr>
          <a:xfrm>
            <a:off x="2378150" y="335450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3DC009E-D6C3-451F-9901-7015C75E29F3}"/>
              </a:ext>
            </a:extLst>
          </p:cNvPr>
          <p:cNvSpPr txBox="1"/>
          <p:nvPr/>
        </p:nvSpPr>
        <p:spPr>
          <a:xfrm>
            <a:off x="604942" y="6226869"/>
            <a:ext cx="5763671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/>
              <a:t>Supplemental Figure S1. Transcriptomic comparison of iPSC and CD34+ macrophages and dendritic cells</a:t>
            </a:r>
            <a:r>
              <a:rPr lang="en-GB" sz="1200" dirty="0"/>
              <a:t>. iPSC were differentiated towards, monocyte (iMON), macrophage (iMC) and dendritic cell (iDC) lineages while CD34+ cells were differentiated towards macrophage (pMC) and dendritic (pDC) cell lineages. Direct comparison of cell types was carried out using Tempo-seq analysis of gene expression levels (A-B). Heatmaps of normalised count values are displayed for selected dust mite component phagocytic receptors (A) and non-immune cell markers (B).</a:t>
            </a:r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2440632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DF5263F-57CB-4F0B-9D37-E2ED2049A46F}"/>
              </a:ext>
            </a:extLst>
          </p:cNvPr>
          <p:cNvSpPr txBox="1"/>
          <p:nvPr/>
        </p:nvSpPr>
        <p:spPr>
          <a:xfrm>
            <a:off x="4761220" y="192680"/>
            <a:ext cx="19399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82A8B05-79D6-4F46-8236-FB364B0BFCBE}"/>
              </a:ext>
            </a:extLst>
          </p:cNvPr>
          <p:cNvSpPr txBox="1"/>
          <p:nvPr/>
        </p:nvSpPr>
        <p:spPr>
          <a:xfrm>
            <a:off x="1975717" y="2109028"/>
            <a:ext cx="468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05A28110-62BF-4942-9A0E-B52F7CCCC5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5385396"/>
              </p:ext>
            </p:extLst>
          </p:nvPr>
        </p:nvGraphicFramePr>
        <p:xfrm>
          <a:off x="2248555" y="2253021"/>
          <a:ext cx="1347421" cy="1259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8" name="Prism 8" r:id="rId4" imgW="3358626" imgH="3140903" progId="Prism8.Document">
                  <p:embed/>
                </p:oleObj>
              </mc:Choice>
              <mc:Fallback>
                <p:oleObj name="Prism 8" r:id="rId4" imgW="3358626" imgH="3140903" progId="Prism8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631CB915-F22B-4ECA-A104-309D92F9C03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48555" y="2253021"/>
                        <a:ext cx="1347421" cy="1259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DBB54DED-77C1-4FD0-951E-E359B4D734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2576545"/>
              </p:ext>
            </p:extLst>
          </p:nvPr>
        </p:nvGraphicFramePr>
        <p:xfrm>
          <a:off x="3663595" y="3529375"/>
          <a:ext cx="1384448" cy="1259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9" name="Prism 8" r:id="rId6" imgW="3453341" imgH="3140903" progId="Prism8.Document">
                  <p:embed/>
                </p:oleObj>
              </mc:Choice>
              <mc:Fallback>
                <p:oleObj name="Prism 8" r:id="rId6" imgW="3453341" imgH="3140903" progId="Prism8.Document">
                  <p:embed/>
                  <p:pic>
                    <p:nvPicPr>
                      <p:cNvPr id="32" name="Object 31">
                        <a:extLst>
                          <a:ext uri="{FF2B5EF4-FFF2-40B4-BE49-F238E27FC236}">
                            <a16:creationId xmlns:a16="http://schemas.microsoft.com/office/drawing/2014/main" id="{CA8737F5-F0AC-4674-AF65-7DEC62FB5A3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663595" y="3529375"/>
                        <a:ext cx="1384448" cy="1259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FA027E87-4AB0-49DE-8B97-A8D9F207649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0490345"/>
              </p:ext>
            </p:extLst>
          </p:nvPr>
        </p:nvGraphicFramePr>
        <p:xfrm>
          <a:off x="3663958" y="2253021"/>
          <a:ext cx="1317612" cy="1259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0" name="Prism 8" r:id="rId8" imgW="3285518" imgH="3140903" progId="Prism8.Document">
                  <p:embed/>
                </p:oleObj>
              </mc:Choice>
              <mc:Fallback>
                <p:oleObj name="Prism 8" r:id="rId8" imgW="3285518" imgH="3140903" progId="Prism8.Document">
                  <p:embed/>
                  <p:pic>
                    <p:nvPicPr>
                      <p:cNvPr id="34" name="Object 33">
                        <a:extLst>
                          <a:ext uri="{FF2B5EF4-FFF2-40B4-BE49-F238E27FC236}">
                            <a16:creationId xmlns:a16="http://schemas.microsoft.com/office/drawing/2014/main" id="{51B65051-3B13-42E4-B890-649DC206026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663958" y="2253021"/>
                        <a:ext cx="1317612" cy="1259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29AB65D6-826B-4768-8B92-9FCF8DB29A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1194194"/>
              </p:ext>
            </p:extLst>
          </p:nvPr>
        </p:nvGraphicFramePr>
        <p:xfrm>
          <a:off x="2264837" y="3527475"/>
          <a:ext cx="1330776" cy="12643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81" name="Prism 8" r:id="rId10" imgW="3306766" imgH="3140903" progId="Prism8.Document">
                  <p:embed/>
                </p:oleObj>
              </mc:Choice>
              <mc:Fallback>
                <p:oleObj name="Prism 8" r:id="rId10" imgW="3306766" imgH="3140903" progId="Prism8.Document">
                  <p:embed/>
                  <p:pic>
                    <p:nvPicPr>
                      <p:cNvPr id="36" name="Object 35">
                        <a:extLst>
                          <a:ext uri="{FF2B5EF4-FFF2-40B4-BE49-F238E27FC236}">
                            <a16:creationId xmlns:a16="http://schemas.microsoft.com/office/drawing/2014/main" id="{C0CCD191-D35F-4495-ABFC-09DCA4B3625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264837" y="3527475"/>
                        <a:ext cx="1330776" cy="12643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259EB4D2-352D-4530-9351-C5192C7439CA}"/>
              </a:ext>
            </a:extLst>
          </p:cNvPr>
          <p:cNvSpPr txBox="1"/>
          <p:nvPr/>
        </p:nvSpPr>
        <p:spPr>
          <a:xfrm>
            <a:off x="868151" y="5787575"/>
            <a:ext cx="5454924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/>
              <a:t>Supplementary Figure S2. TempOseq endogenous control gene expression across treatments </a:t>
            </a:r>
            <a:r>
              <a:rPr lang="en-GB" sz="1200" dirty="0"/>
              <a:t>. Macrophage lineage cells were derived from iPSC (iMC) and CD34+ (pMC) and exposed to cerium dioxide (CeO2) or silicon dioxide (SiO2) (</a:t>
            </a:r>
            <a:r>
              <a:rPr lang="en-GB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5 µg/ml</a:t>
            </a:r>
            <a:r>
              <a:rPr lang="en-GB" sz="1200" dirty="0"/>
              <a:t>) in the absence or presence of house dust mite </a:t>
            </a:r>
            <a:r>
              <a:rPr lang="en-GB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HDM, </a:t>
            </a:r>
            <a:r>
              <a:rPr lang="en-GB" sz="1200" dirty="0">
                <a:effectLst/>
                <a:latin typeface="Tahoma" panose="020B060403050404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GB" sz="1200" dirty="0">
                <a:effectLst/>
                <a:latin typeface="Tahoma" panose="020B0604030504040204" pitchFamily="34" charset="0"/>
                <a:ea typeface="SimSun" panose="02010600030101010101" pitchFamily="2" charset="-122"/>
              </a:rPr>
              <a:t>5 µg/ml</a:t>
            </a:r>
            <a:r>
              <a:rPr lang="en-GB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for 24hrs. </a:t>
            </a:r>
            <a:r>
              <a:rPr lang="en-GB" sz="1200" dirty="0"/>
              <a:t>Tempo-seq analysis of gene expression levels for endogenous control genes are displayed as normalised count data.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GB" sz="1200" dirty="0"/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5476988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DF5263F-57CB-4F0B-9D37-E2ED2049A46F}"/>
              </a:ext>
            </a:extLst>
          </p:cNvPr>
          <p:cNvSpPr txBox="1"/>
          <p:nvPr/>
        </p:nvSpPr>
        <p:spPr>
          <a:xfrm>
            <a:off x="4761220" y="192680"/>
            <a:ext cx="185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S1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CC5951E-BABE-4BE2-BB8C-FB03761578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7395355"/>
              </p:ext>
            </p:extLst>
          </p:nvPr>
        </p:nvGraphicFramePr>
        <p:xfrm>
          <a:off x="1270000" y="2682225"/>
          <a:ext cx="4179570" cy="813755"/>
        </p:xfrm>
        <a:graphic>
          <a:graphicData uri="http://schemas.openxmlformats.org/drawingml/2006/table">
            <a:tbl>
              <a:tblPr firstRow="1" firstCol="1" bandRow="1"/>
              <a:tblGrid>
                <a:gridCol w="1393190">
                  <a:extLst>
                    <a:ext uri="{9D8B030D-6E8A-4147-A177-3AD203B41FA5}">
                      <a16:colId xmlns:a16="http://schemas.microsoft.com/office/drawing/2014/main" val="2859717328"/>
                    </a:ext>
                  </a:extLst>
                </a:gridCol>
                <a:gridCol w="1393190">
                  <a:extLst>
                    <a:ext uri="{9D8B030D-6E8A-4147-A177-3AD203B41FA5}">
                      <a16:colId xmlns:a16="http://schemas.microsoft.com/office/drawing/2014/main" val="3308041691"/>
                    </a:ext>
                  </a:extLst>
                </a:gridCol>
                <a:gridCol w="1393190">
                  <a:extLst>
                    <a:ext uri="{9D8B030D-6E8A-4147-A177-3AD203B41FA5}">
                      <a16:colId xmlns:a16="http://schemas.microsoft.com/office/drawing/2014/main" val="94213594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Antibody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Clon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b="1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Catalogue #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33934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CD14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MPHIP9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940005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96865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CD11c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3.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94036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54359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CD1c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F10/21A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940083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09923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HLA-DR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G46-6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94001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9101790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5657AC90-7550-4577-8C44-CC1D2481A0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0000" y="2436003"/>
            <a:ext cx="3214914" cy="4924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ahoma" panose="020B0604030504040204" pitchFamily="34" charset="0"/>
                <a:ea typeface="SimSun" panose="02010600030101010101" pitchFamily="2" charset="-122"/>
                <a:cs typeface="Tahoma" panose="020B0604030504040204" pitchFamily="34" charset="0"/>
              </a:rPr>
              <a:t>T</a:t>
            </a:r>
            <a:r>
              <a:rPr kumimoji="0" lang="en-GB" altLang="en-US" sz="800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Tahoma" panose="020B0604030504040204" pitchFamily="34" charset="0"/>
                <a:ea typeface="SimSun" panose="02010600030101010101" pitchFamily="2" charset="-122"/>
                <a:cs typeface="Tahoma" panose="020B0604030504040204" pitchFamily="34" charset="0"/>
              </a:rPr>
              <a:t>able S</a:t>
            </a:r>
            <a:r>
              <a:rPr kumimoji="0" lang="en-GB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ahoma" panose="020B0604030504040204" pitchFamily="34" charset="0"/>
                <a:ea typeface="SimSun" panose="02010600030101010101" pitchFamily="2" charset="-122"/>
                <a:cs typeface="Tahoma" panose="020B0604030504040204" pitchFamily="34" charset="0"/>
              </a:rPr>
              <a:t>1 BD AbSeq Antibodies</a:t>
            </a:r>
            <a:endParaRPr kumimoji="0" lang="en-GB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57879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DF5263F-57CB-4F0B-9D37-E2ED2049A46F}"/>
              </a:ext>
            </a:extLst>
          </p:cNvPr>
          <p:cNvSpPr txBox="1"/>
          <p:nvPr/>
        </p:nvSpPr>
        <p:spPr>
          <a:xfrm>
            <a:off x="4761220" y="192680"/>
            <a:ext cx="1859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S2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6CC5951E-BABE-4BE2-BB8C-FB03761578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4934497"/>
              </p:ext>
            </p:extLst>
          </p:nvPr>
        </p:nvGraphicFramePr>
        <p:xfrm>
          <a:off x="1270000" y="2682225"/>
          <a:ext cx="4416698" cy="1031685"/>
        </p:xfrm>
        <a:graphic>
          <a:graphicData uri="http://schemas.openxmlformats.org/drawingml/2006/table">
            <a:tbl>
              <a:tblPr firstRow="1" firstCol="1" bandRow="1"/>
              <a:tblGrid>
                <a:gridCol w="889726">
                  <a:extLst>
                    <a:ext uri="{9D8B030D-6E8A-4147-A177-3AD203B41FA5}">
                      <a16:colId xmlns:a16="http://schemas.microsoft.com/office/drawing/2014/main" val="2859717328"/>
                    </a:ext>
                  </a:extLst>
                </a:gridCol>
                <a:gridCol w="1872343">
                  <a:extLst>
                    <a:ext uri="{9D8B030D-6E8A-4147-A177-3AD203B41FA5}">
                      <a16:colId xmlns:a16="http://schemas.microsoft.com/office/drawing/2014/main" val="3308041691"/>
                    </a:ext>
                  </a:extLst>
                </a:gridCol>
                <a:gridCol w="1654629">
                  <a:extLst>
                    <a:ext uri="{9D8B030D-6E8A-4147-A177-3AD203B41FA5}">
                      <a16:colId xmlns:a16="http://schemas.microsoft.com/office/drawing/2014/main" val="94213594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Gene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Forward (5’-3’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b="1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SimSun" panose="02010600030101010101" pitchFamily="2" charset="-122"/>
                          <a:cs typeface="Times New Roman" panose="02020603050405020304" pitchFamily="18" charset="0"/>
                        </a:rPr>
                        <a:t>Reverse (5’-3’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SimSun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33934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ITGAM</a:t>
                      </a:r>
                      <a:endParaRPr lang="en-GB" sz="800" dirty="0">
                        <a:effectLst/>
                        <a:latin typeface="Tahoma" panose="020B0604030504040204" pitchFamily="34" charset="0"/>
                        <a:ea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CCTTGACCTTATGTCATGG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TGTGCTGTAGTCGCA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96865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ITGAX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GGATGCCGCCAAAATTCT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ATTGCATAGCGGATGATGC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54359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MARCO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AGCGGGTAGACAACTTCA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TGCTCCATCTCGTCCCAT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099239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MRC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GGTTGCTATCACTCTCTATG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TTCTTGTCTGTTGCCGTAGT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910179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GB" sz="800" dirty="0"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CCR7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TGAGGTCACGGACGATTAC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ahoma" panose="020B0604030504040204" pitchFamily="34" charset="0"/>
                          <a:ea typeface="Tahoma" panose="020B0604030504040204" pitchFamily="34" charset="0"/>
                          <a:cs typeface="Tahoma" panose="020B0604030504040204" pitchFamily="34" charset="0"/>
                        </a:rPr>
                        <a:t>GTAGGCCCACGAAACAAATG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353375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endParaRPr lang="en-GB" sz="400" dirty="0">
                        <a:effectLst/>
                        <a:latin typeface="Tahoma" panose="020B0604030504040204" pitchFamily="34" charset="0"/>
                        <a:ea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endParaRPr lang="en-GB" sz="400" dirty="0">
                        <a:effectLst/>
                        <a:latin typeface="Tahoma" panose="020B0604030504040204" pitchFamily="34" charset="0"/>
                        <a:ea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endParaRPr lang="en-GB" sz="400" dirty="0">
                        <a:effectLst/>
                        <a:latin typeface="Tahoma" panose="020B0604030504040204" pitchFamily="34" charset="0"/>
                        <a:ea typeface="Tahoma" panose="020B0604030504040204" pitchFamily="34" charset="0"/>
                        <a:cs typeface="Tahoma" panose="020B060403050404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920836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5657AC90-7550-4577-8C44-CC1D2481A0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3872" y="2466781"/>
            <a:ext cx="3214914" cy="2154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ahoma" panose="020B0604030504040204" pitchFamily="34" charset="0"/>
                <a:ea typeface="SimSun" panose="02010600030101010101" pitchFamily="2" charset="-122"/>
                <a:cs typeface="Tahoma" panose="020B0604030504040204" pitchFamily="34" charset="0"/>
              </a:rPr>
              <a:t>T</a:t>
            </a:r>
            <a:r>
              <a:rPr kumimoji="0" lang="en-GB" altLang="en-US" sz="800" b="1" i="0" u="none" strike="noStrike" cap="none" normalizeH="0" baseline="0" dirty="0" bmk="">
                <a:ln>
                  <a:noFill/>
                </a:ln>
                <a:solidFill>
                  <a:schemeClr val="tx1"/>
                </a:solidFill>
                <a:effectLst/>
                <a:latin typeface="Tahoma" panose="020B0604030504040204" pitchFamily="34" charset="0"/>
                <a:ea typeface="SimSun" panose="02010600030101010101" pitchFamily="2" charset="-122"/>
                <a:cs typeface="Tahoma" panose="020B0604030504040204" pitchFamily="34" charset="0"/>
              </a:rPr>
              <a:t>able S2</a:t>
            </a:r>
            <a:r>
              <a:rPr kumimoji="0" lang="en-GB" altLang="en-US" sz="8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ahoma" panose="020B0604030504040204" pitchFamily="34" charset="0"/>
                <a:ea typeface="SimSun" panose="02010600030101010101" pitchFamily="2" charset="-122"/>
                <a:cs typeface="Tahoma" panose="020B0604030504040204" pitchFamily="34" charset="0"/>
              </a:rPr>
              <a:t> PCR Primers</a:t>
            </a:r>
            <a:endParaRPr kumimoji="0" lang="en-GB" altLang="en-US" sz="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544255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768</TotalTime>
  <Words>293</Words>
  <Application>Microsoft Office PowerPoint</Application>
  <PresentationFormat>A4 Paper (210x297 mm)</PresentationFormat>
  <Paragraphs>81</Paragraphs>
  <Slides>4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ahoma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 Leonard</dc:creator>
  <cp:lastModifiedBy>Martin Leonard</cp:lastModifiedBy>
  <cp:revision>908</cp:revision>
  <dcterms:created xsi:type="dcterms:W3CDTF">2020-11-23T13:58:01Z</dcterms:created>
  <dcterms:modified xsi:type="dcterms:W3CDTF">2023-03-15T10:14:54Z</dcterms:modified>
</cp:coreProperties>
</file>